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7" d="100"/>
          <a:sy n="87" d="100"/>
        </p:scale>
        <p:origin x="1512" y="-38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9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65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4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8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20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7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45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4568-5ACD-435D-8C4D-5A025A52F662}" type="datetimeFigureOut">
              <a:rPr lang="en-GB" smtClean="0"/>
              <a:t>2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90"/>
          <p:cNvSpPr txBox="1"/>
          <p:nvPr/>
        </p:nvSpPr>
        <p:spPr>
          <a:xfrm>
            <a:off x="3919218" y="210862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050023" y="1008153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953384" y="6101941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069580" y="10481640"/>
            <a:ext cx="4012810" cy="3431848"/>
            <a:chOff x="6739848" y="6560793"/>
            <a:chExt cx="4012810" cy="3431848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390913" y="6766639"/>
              <a:ext cx="2986198" cy="2706366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8111352" y="943447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305414" y="943447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8846629" y="943447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9649004" y="943447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989141" y="8155955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989141" y="7176136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989141" y="668514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989141" y="7657629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989141" y="9135775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989141" y="8654282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5971048" y="7944936"/>
              <a:ext cx="18453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9954498" y="8415908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7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0269834" y="8754005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8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9471049" y="9094239"/>
              <a:ext cx="9524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 = 0.017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7616627" y="9684864"/>
              <a:ext cx="25731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verall survival time (years)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8613395" y="6560793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G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019974" y="6347745"/>
            <a:ext cx="4007010" cy="3541068"/>
            <a:chOff x="6745648" y="2440188"/>
            <a:chExt cx="4007010" cy="354106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94916" y="2742133"/>
              <a:ext cx="2982195" cy="2678861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8141055" y="539137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311214" y="538566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9832060" y="539230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994941" y="411803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994941" y="3138214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994941" y="2647218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994941" y="361970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994941" y="509785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994941" y="461636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5976848" y="3907014"/>
              <a:ext cx="18453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0269834" y="3889733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5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9478278" y="2957283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5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484882" y="4994450"/>
              <a:ext cx="9524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 &lt; 0.001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746812" y="5673479"/>
              <a:ext cx="25731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verall survival time (years)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578877" y="2440188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RP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8970897" y="539453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938775" y="2382950"/>
            <a:ext cx="3847679" cy="3547941"/>
            <a:chOff x="1701794" y="2426155"/>
            <a:chExt cx="3847679" cy="354794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52277" y="2760606"/>
              <a:ext cx="2738902" cy="2652688"/>
            </a:xfrm>
            <a:prstGeom prst="rect">
              <a:avLst/>
            </a:prstGeom>
          </p:spPr>
        </p:pic>
        <p:grpSp>
          <p:nvGrpSpPr>
            <p:cNvPr id="9" name="Group 8"/>
            <p:cNvGrpSpPr/>
            <p:nvPr/>
          </p:nvGrpSpPr>
          <p:grpSpPr>
            <a:xfrm>
              <a:off x="1701794" y="2426155"/>
              <a:ext cx="3847679" cy="3547941"/>
              <a:chOff x="1701794" y="2426155"/>
              <a:chExt cx="3847679" cy="3547941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2689782" y="538566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267360" y="538566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088477" y="538566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502446" y="538566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928099" y="537348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51087" y="411803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951087" y="3138214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951087" y="2647218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951087" y="3619707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951087" y="509785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951087" y="4616360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932994" y="3907014"/>
                <a:ext cx="18453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rvival probability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855102" y="4135004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66</a:t>
                </a:r>
                <a:endParaRPr lang="en-GB" sz="1400" b="1" dirty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066649" y="3627081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67</a:t>
                </a:r>
                <a:endPara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515147" y="4991165"/>
                <a:ext cx="95244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 &lt; 0.001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552434" y="5666319"/>
                <a:ext cx="257314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verall survival time (years)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3569320" y="2426155"/>
                <a:ext cx="62388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IRC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4304294" y="5382171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4731365" y="5377489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52851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</TotalTime>
  <Words>78</Words>
  <Application>Microsoft Office PowerPoint</Application>
  <PresentationFormat>Custom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ryfysgol Bangor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say McFarlane</dc:creator>
  <cp:lastModifiedBy>Ramsay McFarlane</cp:lastModifiedBy>
  <cp:revision>24</cp:revision>
  <cp:lastPrinted>2016-08-12T10:52:36Z</cp:lastPrinted>
  <dcterms:created xsi:type="dcterms:W3CDTF">2016-08-11T08:24:58Z</dcterms:created>
  <dcterms:modified xsi:type="dcterms:W3CDTF">2017-02-23T14:28:06Z</dcterms:modified>
</cp:coreProperties>
</file>